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96" r:id="rId1"/>
  </p:sldMasterIdLst>
  <p:sldIdLst>
    <p:sldId id="258" r:id="rId2"/>
  </p:sldIdLst>
  <p:sldSz cx="6858000" cy="8229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86" d="100"/>
          <a:sy n="86" d="100"/>
        </p:scale>
        <p:origin x="127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346836"/>
            <a:ext cx="5829300" cy="286512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322446"/>
            <a:ext cx="5143500" cy="1986914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003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240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38150"/>
            <a:ext cx="1478756" cy="697420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38150"/>
            <a:ext cx="4350544" cy="69742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04397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630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051688"/>
            <a:ext cx="5915025" cy="3423284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507358"/>
            <a:ext cx="5915025" cy="1800224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46100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190750"/>
            <a:ext cx="29146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190750"/>
            <a:ext cx="2914650" cy="52216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3955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38152"/>
            <a:ext cx="5915025" cy="15906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017396"/>
            <a:ext cx="2901255" cy="98869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006090"/>
            <a:ext cx="2901255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017396"/>
            <a:ext cx="2915543" cy="98869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006090"/>
            <a:ext cx="2915543" cy="442150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3641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21033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7709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48640"/>
            <a:ext cx="2211884" cy="19202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184912"/>
            <a:ext cx="3471863" cy="584835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68880"/>
            <a:ext cx="2211884" cy="457390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5527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48640"/>
            <a:ext cx="2211884" cy="19202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184912"/>
            <a:ext cx="3471863" cy="584835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468880"/>
            <a:ext cx="2211884" cy="457390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47826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38152"/>
            <a:ext cx="5915025" cy="15906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190750"/>
            <a:ext cx="5915025" cy="52216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7627622"/>
            <a:ext cx="154305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D019DE-B8FD-48B2-8070-ACBE374E5355}" type="datetimeFigureOut">
              <a:rPr lang="en-US" smtClean="0"/>
              <a:t>12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7627622"/>
            <a:ext cx="2314575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7627622"/>
            <a:ext cx="1543050" cy="4381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DE73BD-DCA0-4B51-B173-0B2D82CF5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4890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CE34048A-AFF1-20EF-104E-2AAFBAE8CE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0060" y="176701"/>
            <a:ext cx="166264" cy="3323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82296" tIns="41148" rIns="82296" bIns="41148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 sz="162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7C1A90B9-8C6E-73A4-1C8B-69DCBA39C4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4011" y="6492472"/>
            <a:ext cx="6438528" cy="15604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82296" tIns="41148" rIns="82296" bIns="41148" numCol="1" anchor="ctr" anchorCtr="0" compatLnSpc="1">
            <a:prstTxWarp prst="textNoShape">
              <a:avLst/>
            </a:prstTxWarp>
            <a:spAutoFit/>
          </a:bodyPr>
          <a:lstStyle/>
          <a:p>
            <a:pPr algn="just" defTabSz="822960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en-US" sz="1600" dirty="0" bmk="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 defTabSz="82296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600" b="1" i="1" dirty="0" bmk="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. Figure </a:t>
            </a:r>
            <a:r>
              <a:rPr lang="sk-SK" altLang="en-US" sz="1600" b="1" i="1" dirty="0" bmk="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altLang="en-US" sz="1600" b="1" i="1" dirty="0" bmk="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en-US" sz="1600" i="1" dirty="0" bmk="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he coverage map of CA I showing (A) tryptic peptide fragments detected in the initial sample (73.1% sequence coverage); (B) tryptic peptide fragment detected in third elution fraction obtained during the epitope extraction experiment</a:t>
            </a:r>
            <a:r>
              <a:rPr lang="cs-CZ" altLang="en-US" sz="1600" i="1" dirty="0" bmk="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 defTabSz="822960" eaLnBrk="0" fontAlgn="base" hangingPunct="0">
              <a:spcBef>
                <a:spcPct val="0"/>
              </a:spcBef>
              <a:spcAft>
                <a:spcPct val="0"/>
              </a:spcAft>
            </a:pPr>
            <a:endParaRPr lang="en-US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Skupina 3">
            <a:extLst>
              <a:ext uri="{FF2B5EF4-FFF2-40B4-BE49-F238E27FC236}">
                <a16:creationId xmlns:a16="http://schemas.microsoft.com/office/drawing/2014/main" id="{ECA4D171-7CBE-1193-67DB-C9AE9A835DBB}"/>
              </a:ext>
            </a:extLst>
          </p:cNvPr>
          <p:cNvGrpSpPr/>
          <p:nvPr/>
        </p:nvGrpSpPr>
        <p:grpSpPr>
          <a:xfrm>
            <a:off x="318934" y="853512"/>
            <a:ext cx="5872635" cy="4677334"/>
            <a:chOff x="0" y="11206"/>
            <a:chExt cx="5872635" cy="4677334"/>
          </a:xfrm>
        </p:grpSpPr>
        <p:pic>
          <p:nvPicPr>
            <p:cNvPr id="5" name="Picture 3">
              <a:extLst>
                <a:ext uri="{FF2B5EF4-FFF2-40B4-BE49-F238E27FC236}">
                  <a16:creationId xmlns:a16="http://schemas.microsoft.com/office/drawing/2014/main" id="{14CA7639-D632-A8EE-CB58-F0BC00FE5316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1" t="58798" r="53462" b="18820"/>
            <a:stretch/>
          </p:blipFill>
          <p:spPr bwMode="auto">
            <a:xfrm>
              <a:off x="263567" y="161660"/>
              <a:ext cx="5603860" cy="21833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4">
              <a:extLst>
                <a:ext uri="{FF2B5EF4-FFF2-40B4-BE49-F238E27FC236}">
                  <a16:creationId xmlns:a16="http://schemas.microsoft.com/office/drawing/2014/main" id="{826C8A85-F44A-7F9F-4879-6753640BE7F6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0" t="59293" r="53793" b="19504"/>
            <a:stretch/>
          </p:blipFill>
          <p:spPr bwMode="auto">
            <a:xfrm>
              <a:off x="249248" y="1827987"/>
              <a:ext cx="5623387" cy="20683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" name="TextovéPole 5">
              <a:extLst>
                <a:ext uri="{FF2B5EF4-FFF2-40B4-BE49-F238E27FC236}">
                  <a16:creationId xmlns:a16="http://schemas.microsoft.com/office/drawing/2014/main" id="{4F3DA28B-F641-8F3A-861B-F98E8C1100D7}"/>
                </a:ext>
              </a:extLst>
            </p:cNvPr>
            <p:cNvSpPr txBox="1"/>
            <p:nvPr/>
          </p:nvSpPr>
          <p:spPr>
            <a:xfrm>
              <a:off x="0" y="11206"/>
              <a:ext cx="3235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000" b="1" dirty="0"/>
                <a:t>A</a:t>
              </a:r>
            </a:p>
          </p:txBody>
        </p:sp>
        <p:sp>
          <p:nvSpPr>
            <p:cNvPr id="8" name="TextovéPole 10">
              <a:extLst>
                <a:ext uri="{FF2B5EF4-FFF2-40B4-BE49-F238E27FC236}">
                  <a16:creationId xmlns:a16="http://schemas.microsoft.com/office/drawing/2014/main" id="{94DD739B-5A0A-2E1D-6D4B-AECC05415A52}"/>
                </a:ext>
              </a:extLst>
            </p:cNvPr>
            <p:cNvSpPr txBox="1"/>
            <p:nvPr/>
          </p:nvSpPr>
          <p:spPr>
            <a:xfrm>
              <a:off x="0" y="1580062"/>
              <a:ext cx="3235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sz="1000" b="1" dirty="0"/>
                <a:t>B</a:t>
              </a:r>
            </a:p>
          </p:txBody>
        </p:sp>
        <p:pic>
          <p:nvPicPr>
            <p:cNvPr id="9" name="Picture 3">
              <a:extLst>
                <a:ext uri="{FF2B5EF4-FFF2-40B4-BE49-F238E27FC236}">
                  <a16:creationId xmlns:a16="http://schemas.microsoft.com/office/drawing/2014/main" id="{CA6D34C4-C8FD-5CA8-913F-1390193733B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801" t="50336" r="24588" b="34268"/>
            <a:stretch/>
          </p:blipFill>
          <p:spPr bwMode="auto">
            <a:xfrm>
              <a:off x="161764" y="4072623"/>
              <a:ext cx="2791453" cy="6159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" name="Picture 3">
              <a:extLst>
                <a:ext uri="{FF2B5EF4-FFF2-40B4-BE49-F238E27FC236}">
                  <a16:creationId xmlns:a16="http://schemas.microsoft.com/office/drawing/2014/main" id="{BF6A1457-F508-97FE-7DFB-8978DCC2571F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801" t="65732" r="24588" b="18871"/>
            <a:stretch/>
          </p:blipFill>
          <p:spPr bwMode="auto">
            <a:xfrm>
              <a:off x="3081182" y="4029666"/>
              <a:ext cx="2791453" cy="6159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" name="Picture 4">
              <a:extLst>
                <a:ext uri="{FF2B5EF4-FFF2-40B4-BE49-F238E27FC236}">
                  <a16:creationId xmlns:a16="http://schemas.microsoft.com/office/drawing/2014/main" id="{B5139830-A3DF-D4DB-491A-4EB976A4A7D5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719" t="31517" r="63435" b="64874"/>
            <a:stretch/>
          </p:blipFill>
          <p:spPr bwMode="auto">
            <a:xfrm>
              <a:off x="161764" y="3892149"/>
              <a:ext cx="387707" cy="1804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22582079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264</TotalTime>
  <Words>49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do Skultety</dc:creator>
  <cp:lastModifiedBy>Ludovit Skultety</cp:lastModifiedBy>
  <cp:revision>20</cp:revision>
  <dcterms:created xsi:type="dcterms:W3CDTF">2023-04-23T08:26:50Z</dcterms:created>
  <dcterms:modified xsi:type="dcterms:W3CDTF">2024-12-04T14:58:32Z</dcterms:modified>
</cp:coreProperties>
</file>